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1" r:id="rId1"/>
  </p:sldMasterIdLst>
  <p:notesMasterIdLst>
    <p:notesMasterId r:id="rId3"/>
  </p:notesMasterIdLst>
  <p:sldIdLst>
    <p:sldId id="4840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39"/>
    <p:restoredTop sz="96006" autoAdjust="0"/>
  </p:normalViewPr>
  <p:slideViewPr>
    <p:cSldViewPr snapToGrid="0">
      <p:cViewPr varScale="1">
        <p:scale>
          <a:sx n="78" d="100"/>
          <a:sy n="78" d="100"/>
        </p:scale>
        <p:origin x="32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43CAF7-936F-5F44-9B2B-A9102139FCC4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47640C-96A2-B84B-B71B-2578F2D698B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0476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9750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0392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5301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2106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856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0087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0189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1367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7876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0254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8738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441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3" r:id="rId2"/>
    <p:sldLayoutId id="2147483674" r:id="rId3"/>
    <p:sldLayoutId id="2147483675" r:id="rId4"/>
    <p:sldLayoutId id="2147483676" r:id="rId5"/>
    <p:sldLayoutId id="2147483677" r:id="rId6"/>
    <p:sldLayoutId id="2147483678" r:id="rId7"/>
    <p:sldLayoutId id="2147483679" r:id="rId8"/>
    <p:sldLayoutId id="2147483680" r:id="rId9"/>
    <p:sldLayoutId id="2147483681" r:id="rId10"/>
    <p:sldLayoutId id="214748368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4">
            <a:extLst>
              <a:ext uri="{FF2B5EF4-FFF2-40B4-BE49-F238E27FC236}">
                <a16:creationId xmlns:a16="http://schemas.microsoft.com/office/drawing/2014/main" id="{BBC60622-97A6-3ED4-2D49-ED0B10FBEB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150406"/>
              </p:ext>
            </p:extLst>
          </p:nvPr>
        </p:nvGraphicFramePr>
        <p:xfrm>
          <a:off x="1418720" y="516201"/>
          <a:ext cx="4020560" cy="76044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00520">
                  <a:extLst>
                    <a:ext uri="{9D8B030D-6E8A-4147-A177-3AD203B41FA5}">
                      <a16:colId xmlns:a16="http://schemas.microsoft.com/office/drawing/2014/main" val="501800579"/>
                    </a:ext>
                  </a:extLst>
                </a:gridCol>
                <a:gridCol w="660826">
                  <a:extLst>
                    <a:ext uri="{9D8B030D-6E8A-4147-A177-3AD203B41FA5}">
                      <a16:colId xmlns:a16="http://schemas.microsoft.com/office/drawing/2014/main" val="958207400"/>
                    </a:ext>
                  </a:extLst>
                </a:gridCol>
                <a:gridCol w="2159214">
                  <a:extLst>
                    <a:ext uri="{9D8B030D-6E8A-4147-A177-3AD203B41FA5}">
                      <a16:colId xmlns:a16="http://schemas.microsoft.com/office/drawing/2014/main" val="433588715"/>
                    </a:ext>
                  </a:extLst>
                </a:gridCol>
              </a:tblGrid>
              <a:tr h="188595">
                <a:tc>
                  <a:txBody>
                    <a:bodyPr/>
                    <a:lstStyle/>
                    <a:p>
                      <a:pPr algn="ctr"/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stance mutations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</a:t>
                      </a:r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vious</a:t>
                      </a:r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ticancer agents</a:t>
                      </a: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3313581237"/>
                  </a:ext>
                </a:extLst>
              </a:tr>
              <a:tr h="257175">
                <a:tc rowSpan="5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 kinase </a:t>
                      </a:r>
                      <a:r>
                        <a:rPr lang="fr-FR" sz="7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main</a:t>
                      </a:r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utations 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406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platin</a:t>
                      </a: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pembrolizumab</a:t>
                      </a: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4082586045"/>
                  </a:ext>
                </a:extLst>
              </a:tr>
              <a:tr h="257175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560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platin</a:t>
                      </a: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endParaRPr lang="fr-FR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1195330885"/>
                  </a:ext>
                </a:extLst>
              </a:tr>
              <a:tr h="257175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3010</a:t>
                      </a:r>
                      <a:endParaRPr lang="fr-FR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platin</a:t>
                      </a: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endParaRPr lang="fr-FR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56020929"/>
                  </a:ext>
                </a:extLst>
              </a:tr>
              <a:tr h="257175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1845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AC</a:t>
                      </a:r>
                    </a:p>
                    <a:p>
                      <a:pPr algn="ctr"/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dafitinib</a:t>
                      </a:r>
                      <a:endParaRPr lang="fr-FR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rvalumab</a:t>
                      </a:r>
                      <a:endParaRPr lang="fr-FR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mbrolizumab + ICOS </a:t>
                      </a: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onist</a:t>
                      </a:r>
                      <a:endParaRPr lang="fr-FR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1427100106"/>
                  </a:ext>
                </a:extLst>
              </a:tr>
              <a:tr h="257175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904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AC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platin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3524223186"/>
                  </a:ext>
                </a:extLst>
              </a:tr>
              <a:tr h="167667">
                <a:tc gridSpan="3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it-IT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1498778207"/>
                  </a:ext>
                </a:extLst>
              </a:tr>
              <a:tr h="257175">
                <a:tc rowSpan="8">
                  <a:txBody>
                    <a:bodyPr/>
                    <a:lstStyle/>
                    <a:p>
                      <a:pPr algn="ctr"/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s in the PI3K/mTOR </a:t>
                      </a:r>
                      <a:r>
                        <a:rPr lang="fr-FR" sz="7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way</a:t>
                      </a:r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15</a:t>
                      </a:r>
                      <a:endParaRPr lang="it-IT" b="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AC</a:t>
                      </a: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1170603533"/>
                  </a:ext>
                </a:extLst>
              </a:tr>
              <a:tr h="257175">
                <a:tc vMerge="1"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2267</a:t>
                      </a:r>
                      <a:endParaRPr lang="it-IT" b="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platin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1073968500"/>
                  </a:ext>
                </a:extLst>
              </a:tr>
              <a:tr h="257175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7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336</a:t>
                      </a:r>
                      <a:endParaRPr lang="it-IT" b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VAC</a:t>
                      </a:r>
                    </a:p>
                    <a:p>
                      <a:pPr algn="ctr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ezolizumab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ezolizumab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+ anti-CSF1R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body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53422236"/>
                  </a:ext>
                </a:extLst>
              </a:tr>
              <a:tr h="257175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521</a:t>
                      </a:r>
                      <a:endParaRPr lang="it-IT" b="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7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isplatin</a:t>
                      </a:r>
                      <a:r>
                        <a:rPr kumimoji="0" lang="fr-FR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+ </a:t>
                      </a:r>
                      <a:r>
                        <a:rPr kumimoji="0" lang="fr-FR" sz="7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emcitabine</a:t>
                      </a:r>
                      <a:endParaRPr kumimoji="0" lang="fr-FR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clitaxel</a:t>
                      </a: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7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rboplatin</a:t>
                      </a:r>
                      <a:r>
                        <a:rPr kumimoji="0" lang="fr-FR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+ paclitaxel</a:t>
                      </a: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1435123837"/>
                  </a:ext>
                </a:extLst>
              </a:tr>
              <a:tr h="188595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1105</a:t>
                      </a:r>
                      <a:endParaRPr lang="it-IT" b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AC</a:t>
                      </a:r>
                    </a:p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mbrolizumab</a:t>
                      </a: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1580152541"/>
                  </a:ext>
                </a:extLst>
              </a:tr>
              <a:tr h="188595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701</a:t>
                      </a:r>
                      <a:endParaRPr lang="it-IT" b="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AC</a:t>
                      </a:r>
                    </a:p>
                    <a:p>
                      <a:pPr algn="ctr"/>
                      <a:r>
                        <a:rPr lang="fr-FR" sz="7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lumab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2281537585"/>
                  </a:ext>
                </a:extLst>
              </a:tr>
              <a:tr h="257175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7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246</a:t>
                      </a:r>
                      <a:endParaRPr lang="it-IT" b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xaliplatin + gemcitabine</a:t>
                      </a:r>
                    </a:p>
                    <a:p>
                      <a:pPr algn="ctr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rboplatin + paclitaxel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02197155"/>
                  </a:ext>
                </a:extLst>
              </a:tr>
              <a:tr h="345921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057</a:t>
                      </a:r>
                      <a:endParaRPr lang="it-IT" b="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AC</a:t>
                      </a: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1798884485"/>
                  </a:ext>
                </a:extLst>
              </a:tr>
              <a:tr h="133240">
                <a:tc gridSpan="3">
                  <a:txBody>
                    <a:bodyPr/>
                    <a:lstStyle/>
                    <a:p>
                      <a:pPr algn="ctr"/>
                      <a:endParaRPr lang="fr-FR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3870360519"/>
                  </a:ext>
                </a:extLst>
              </a:tr>
              <a:tr h="345921">
                <a:tc rowSpan="3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th</a:t>
                      </a:r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GFR3 kinase </a:t>
                      </a:r>
                      <a:r>
                        <a:rPr lang="fr-FR" sz="7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main</a:t>
                      </a:r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utations  </a:t>
                      </a:r>
                    </a:p>
                    <a:p>
                      <a:pPr algn="ctr"/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d PI3K/mTOR </a:t>
                      </a:r>
                      <a:r>
                        <a:rPr lang="fr-FR" sz="7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thway</a:t>
                      </a:r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utations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410</a:t>
                      </a:r>
                      <a:endParaRPr lang="it-IT" b="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AC</a:t>
                      </a:r>
                    </a:p>
                    <a:p>
                      <a:pPr algn="ctr"/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rvalumab</a:t>
                      </a: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melimumab</a:t>
                      </a:r>
                      <a:endParaRPr lang="fr-FR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2975847193"/>
                  </a:ext>
                </a:extLst>
              </a:tr>
              <a:tr h="345921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86</a:t>
                      </a:r>
                      <a:endParaRPr lang="it-IT" b="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splatin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/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rboplatin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+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mcitabin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3372514176"/>
                  </a:ext>
                </a:extLst>
              </a:tr>
              <a:tr h="345921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22</a:t>
                      </a:r>
                      <a:endParaRPr lang="it-IT" b="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platin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AC</a:t>
                      </a: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platin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clitaxel</a:t>
                      </a: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1034962428"/>
                  </a:ext>
                </a:extLst>
              </a:tr>
              <a:tr h="170077">
                <a:tc gridSpan="3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it-IT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 hMerge="1"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3579319550"/>
                  </a:ext>
                </a:extLst>
              </a:tr>
              <a:tr h="345921">
                <a:tc rowSpan="5">
                  <a:txBody>
                    <a:bodyPr/>
                    <a:lstStyle/>
                    <a:p>
                      <a:pPr algn="ctr"/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FGFR or PI3K/mTOR mutations 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104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platin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AC</a:t>
                      </a: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platin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paclitaxel</a:t>
                      </a: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3973086045"/>
                  </a:ext>
                </a:extLst>
              </a:tr>
              <a:tr h="345921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103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platin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cetaxel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3601710647"/>
                  </a:ext>
                </a:extLst>
              </a:tr>
              <a:tr h="345921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371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AC</a:t>
                      </a: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ezolizumab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877455393"/>
                  </a:ext>
                </a:extLst>
              </a:tr>
              <a:tr h="345921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411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platin</a:t>
                      </a: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pembrolizumab</a:t>
                      </a: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3974892613"/>
                  </a:ext>
                </a:extLst>
              </a:tr>
              <a:tr h="345921">
                <a:tc vMerge="1">
                  <a:txBody>
                    <a:bodyPr/>
                    <a:lstStyle/>
                    <a:p>
                      <a:pPr algn="ctr"/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615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platin</a:t>
                      </a: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endParaRPr lang="fr-FR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mbrolizumab</a:t>
                      </a: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zopanib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 anchor="ctr"/>
                </a:tc>
                <a:extLst>
                  <a:ext uri="{0D108BD9-81ED-4DB2-BD59-A6C34878D82A}">
                    <a16:rowId xmlns:a16="http://schemas.microsoft.com/office/drawing/2014/main" val="2827150286"/>
                  </a:ext>
                </a:extLst>
              </a:tr>
            </a:tbl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04BAFE91-347C-77B7-420C-BE4469EF49ED}"/>
              </a:ext>
            </a:extLst>
          </p:cNvPr>
          <p:cNvSpPr txBox="1"/>
          <p:nvPr/>
        </p:nvSpPr>
        <p:spPr>
          <a:xfrm>
            <a:off x="0" y="0"/>
            <a:ext cx="21301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2FC0E29F-480B-05B6-F7BA-FF50060A7B9D}"/>
              </a:ext>
            </a:extLst>
          </p:cNvPr>
          <p:cNvSpPr txBox="1"/>
          <p:nvPr/>
        </p:nvSpPr>
        <p:spPr>
          <a:xfrm>
            <a:off x="169333" y="8490922"/>
            <a:ext cx="6519334" cy="7562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2. Systemic treatment received by patients prior to selective FGFR inhibitors, according to the detection of FGFR kinase domain mutations and/or PI3K/mTOR pathway alterations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VAC: methotrexate, vinblastine, doxorubicin, cisplatin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56715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38</TotalTime>
  <Words>193</Words>
  <Application>Microsoft Macintosh PowerPoint</Application>
  <PresentationFormat>A4 (21x29,7 cm)</PresentationFormat>
  <Paragraphs>7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82</cp:revision>
  <dcterms:created xsi:type="dcterms:W3CDTF">2022-12-10T11:29:14Z</dcterms:created>
  <dcterms:modified xsi:type="dcterms:W3CDTF">2023-04-01T16:44:46Z</dcterms:modified>
</cp:coreProperties>
</file>